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5"/>
  </p:notesMasterIdLst>
  <p:sldIdLst>
    <p:sldId id="256" r:id="rId2"/>
    <p:sldId id="257" r:id="rId3"/>
    <p:sldId id="258" r:id="rId4"/>
  </p:sldIdLst>
  <p:sldSz cx="7772400" cy="10058400"/>
  <p:notesSz cx="6858000" cy="9144000"/>
  <p:embeddedFontLst>
    <p:embeddedFont>
      <p:font typeface="Oxygen" panose="02000503000000000000" pitchFamily="2" charset="77"/>
      <p:regular r:id="rId6"/>
      <p:bold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747775"/>
          </p15:clr>
        </p15:guide>
        <p15:guide id="2" pos="2448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4401DF4-C9C9-9A62-4230-D2A0C43947D0}" v="6" dt="2024-06-24T16:32:24.0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66"/>
  </p:normalViewPr>
  <p:slideViewPr>
    <p:cSldViewPr snapToGrid="0">
      <p:cViewPr varScale="1">
        <p:scale>
          <a:sx n="78" d="100"/>
          <a:sy n="78" d="100"/>
        </p:scale>
        <p:origin x="3176" y="19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font" Target="fonts/font2.fntdata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ueno, Andrew N." userId="S::anb2200@cumc.columbia.edu::629e58cd-488d-4412-94a5-af250393baab" providerId="AD" clId="Web-{D4401DF4-C9C9-9A62-4230-D2A0C43947D0}"/>
    <pc:docChg chg="modSld">
      <pc:chgData name="Bueno, Andrew N." userId="S::anb2200@cumc.columbia.edu::629e58cd-488d-4412-94a5-af250393baab" providerId="AD" clId="Web-{D4401DF4-C9C9-9A62-4230-D2A0C43947D0}" dt="2024-06-24T16:32:24.087" v="5" actId="1076"/>
      <pc:docMkLst>
        <pc:docMk/>
      </pc:docMkLst>
      <pc:sldChg chg="modSp">
        <pc:chgData name="Bueno, Andrew N." userId="S::anb2200@cumc.columbia.edu::629e58cd-488d-4412-94a5-af250393baab" providerId="AD" clId="Web-{D4401DF4-C9C9-9A62-4230-D2A0C43947D0}" dt="2024-06-24T16:32:24.087" v="5" actId="1076"/>
        <pc:sldMkLst>
          <pc:docMk/>
          <pc:sldMk cId="0" sldId="258"/>
        </pc:sldMkLst>
        <pc:spChg chg="mod">
          <ac:chgData name="Bueno, Andrew N." userId="S::anb2200@cumc.columbia.edu::629e58cd-488d-4412-94a5-af250393baab" providerId="AD" clId="Web-{D4401DF4-C9C9-9A62-4230-D2A0C43947D0}" dt="2024-06-24T16:32:24.087" v="5" actId="1076"/>
          <ac:spMkLst>
            <pc:docMk/>
            <pc:sldMk cId="0" sldId="258"/>
            <ac:spMk id="68" creationId="{00000000-0000-0000-0000-000000000000}"/>
          </ac:spMkLst>
        </pc:spChg>
        <pc:spChg chg="mod">
          <ac:chgData name="Bueno, Andrew N." userId="S::anb2200@cumc.columbia.edu::629e58cd-488d-4412-94a5-af250393baab" providerId="AD" clId="Web-{D4401DF4-C9C9-9A62-4230-D2A0C43947D0}" dt="2024-06-24T16:32:07.212" v="1" actId="1076"/>
          <ac:spMkLst>
            <pc:docMk/>
            <pc:sldMk cId="0" sldId="258"/>
            <ac:spMk id="69" creationId="{00000000-0000-0000-0000-000000000000}"/>
          </ac:spMkLst>
        </pc:spChg>
        <pc:spChg chg="mod">
          <ac:chgData name="Bueno, Andrew N." userId="S::anb2200@cumc.columbia.edu::629e58cd-488d-4412-94a5-af250393baab" providerId="AD" clId="Web-{D4401DF4-C9C9-9A62-4230-D2A0C43947D0}" dt="2024-06-24T16:32:16.118" v="3" actId="14100"/>
          <ac:spMkLst>
            <pc:docMk/>
            <pc:sldMk cId="0" sldId="258"/>
            <ac:spMk id="71" creationId="{00000000-0000-0000-0000-000000000000}"/>
          </ac:spMkLst>
        </pc:spChg>
        <pc:cxnChg chg="mod">
          <ac:chgData name="Bueno, Andrew N." userId="S::anb2200@cumc.columbia.edu::629e58cd-488d-4412-94a5-af250393baab" providerId="AD" clId="Web-{D4401DF4-C9C9-9A62-4230-D2A0C43947D0}" dt="2024-06-24T16:32:20.196" v="4" actId="1076"/>
          <ac:cxnSpMkLst>
            <pc:docMk/>
            <pc:sldMk cId="0" sldId="258"/>
            <ac:cxnSpMk id="72" creationId="{00000000-0000-0000-0000-000000000000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04480" y="685800"/>
            <a:ext cx="2649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4480" y="685800"/>
            <a:ext cx="2649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g232d7e88b16_0_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9538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0" name="Google Shape;60;g232d7e88b16_0_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g232d7e88b16_0_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9538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6" name="Google Shape;66;g232d7e88b16_0_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64952" y="1456058"/>
            <a:ext cx="7242600" cy="40140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64945" y="5542289"/>
            <a:ext cx="7242600" cy="1550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64945" y="2163089"/>
            <a:ext cx="7242600" cy="3839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64945" y="6164351"/>
            <a:ext cx="7242600" cy="2543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64945" y="4206107"/>
            <a:ext cx="7242600" cy="1646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33999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107540" y="2253729"/>
            <a:ext cx="3399900" cy="6681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64945" y="1086507"/>
            <a:ext cx="2386800" cy="14778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64945" y="2717440"/>
            <a:ext cx="2386800" cy="6217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16713" y="880293"/>
            <a:ext cx="5412600" cy="799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886200" y="-244"/>
            <a:ext cx="3886200" cy="100584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25675" y="2411542"/>
            <a:ext cx="3438300" cy="2898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25675" y="5481569"/>
            <a:ext cx="3438300" cy="24153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198575" y="1415969"/>
            <a:ext cx="3261600" cy="7226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64945" y="8273124"/>
            <a:ext cx="5099100" cy="1183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>
            <a:spLocks noGrp="1"/>
          </p:cNvSpPr>
          <p:nvPr>
            <p:ph type="ctrTitle"/>
          </p:nvPr>
        </p:nvSpPr>
        <p:spPr>
          <a:xfrm>
            <a:off x="264900" y="296900"/>
            <a:ext cx="7242600" cy="7371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 fontScale="90000"/>
          </a:bodyPr>
          <a:lstStyle/>
          <a:p>
            <a:pPr marL="0" lvl="0" indent="0" algn="ctr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sz="2322" b="1">
                <a:latin typeface="Oxygen"/>
                <a:ea typeface="Oxygen"/>
                <a:cs typeface="Oxygen"/>
                <a:sym typeface="Oxygen"/>
              </a:rPr>
              <a:t>Using Spanish During a Physical Exam</a:t>
            </a:r>
            <a:endParaRPr sz="2322" b="1"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ctr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ct val="83193"/>
              <a:buFont typeface="Arial"/>
              <a:buNone/>
            </a:pPr>
            <a:r>
              <a:rPr lang="en" sz="1322">
                <a:latin typeface="Oxygen"/>
                <a:ea typeface="Oxygen"/>
                <a:cs typeface="Oxygen"/>
                <a:sym typeface="Oxygen"/>
              </a:rPr>
              <a:t>Developed by Andrew Bueno &amp; Helen Woolcock ‘MS4 with help from Dr. Ana Esteban</a:t>
            </a:r>
            <a:endParaRPr sz="1322">
              <a:latin typeface="Oxygen"/>
              <a:ea typeface="Oxygen"/>
              <a:cs typeface="Oxygen"/>
              <a:sym typeface="Oxygen"/>
            </a:endParaRPr>
          </a:p>
        </p:txBody>
      </p:sp>
      <p:sp>
        <p:nvSpPr>
          <p:cNvPr id="55" name="Google Shape;55;p13"/>
          <p:cNvSpPr txBox="1"/>
          <p:nvPr/>
        </p:nvSpPr>
        <p:spPr>
          <a:xfrm>
            <a:off x="264900" y="1293425"/>
            <a:ext cx="6198600" cy="213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b="1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Introductions:</a:t>
            </a:r>
            <a:endParaRPr b="1">
              <a:solidFill>
                <a:srgbClr val="FF0000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Hola, me llamo ___________ y soy estudiante de medicina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Hello, my name is ____________ and I am a medical student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Ahora voy a hacer un exámen físico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 am now going to do a physical exam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Solo hablo un poco de español. El intérprete me va a ayudar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 only speak a little Spanish. The interpreter will help me out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</p:txBody>
      </p:sp>
      <p:sp>
        <p:nvSpPr>
          <p:cNvPr id="56" name="Google Shape;56;p13"/>
          <p:cNvSpPr txBox="1"/>
          <p:nvPr/>
        </p:nvSpPr>
        <p:spPr>
          <a:xfrm>
            <a:off x="205350" y="3387575"/>
            <a:ext cx="7155600" cy="213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b="1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Cardiac exam (Heart sounds, pulses, carotid bruit):</a:t>
            </a:r>
            <a:endParaRPr b="1">
              <a:solidFill>
                <a:srgbClr val="FF0000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4572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Ahora, voy a escuchar el corazón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 am now going to listen to your heart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Voy a tomar el pulso aquí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 am going to take your pulse here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Acuéstese en la mesa. Mire a la (</a:t>
            </a:r>
            <a:r>
              <a:rPr lang="en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derecha</a:t>
            </a: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</a:t>
            </a:r>
            <a:r>
              <a:rPr lang="en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izquierda</a:t>
            </a: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). Aguante la respiración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ay back on the table. Look to your (</a:t>
            </a:r>
            <a:r>
              <a:rPr lang="en" i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right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</a:t>
            </a:r>
            <a:r>
              <a:rPr lang="en" i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eft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). Hold your breath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</p:txBody>
      </p:sp>
      <p:sp>
        <p:nvSpPr>
          <p:cNvPr id="57" name="Google Shape;57;p13"/>
          <p:cNvSpPr txBox="1"/>
          <p:nvPr/>
        </p:nvSpPr>
        <p:spPr>
          <a:xfrm>
            <a:off x="205350" y="5845325"/>
            <a:ext cx="6317700" cy="3374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b="1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Lung exam (Breath sounds, percussion, tactile fremitus):</a:t>
            </a:r>
            <a:endParaRPr b="1">
              <a:solidFill>
                <a:srgbClr val="FF0000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Siéntese adelante, por favor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it forward, please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Ahora, voy a escuchar los pulmones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 am now going to listen to your lungs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Respire profundo. Respire normal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Breathe deep. Breathe normally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Voy a tocarle así en la espalda para escuchar el sonido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’m going to tap your back like this to hear the sound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Voy a poner mis manos en su espalda. Díga treinta y tres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’m going to put my hands on your back. Say thirty three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45720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/>
          <p:nvPr/>
        </p:nvSpPr>
        <p:spPr>
          <a:xfrm>
            <a:off x="264900" y="109025"/>
            <a:ext cx="7507500" cy="4117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GI exam (Auscultation, Palpation):</a:t>
            </a:r>
            <a:endParaRPr b="1" dirty="0">
              <a:solidFill>
                <a:srgbClr val="FF0000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cuéstes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or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favor. Voy 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oner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a mesa plana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ay back, please. I am going to make the table flat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hor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voy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cuchar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barrig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vientr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tómag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 am now going to listen to your belly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L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voy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resionar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n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barrig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vientr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tómag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ígam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i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uel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 am going to press on your belly. Tell me if it hurts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¿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ónd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uel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á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?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Where does it hurt the most?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¿L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uel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uand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quit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resión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?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oes it hurt when I take off pressure?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</p:txBody>
      </p:sp>
      <p:sp>
        <p:nvSpPr>
          <p:cNvPr id="63" name="Google Shape;63;p14"/>
          <p:cNvSpPr txBox="1"/>
          <p:nvPr/>
        </p:nvSpPr>
        <p:spPr>
          <a:xfrm>
            <a:off x="327425" y="3333750"/>
            <a:ext cx="6979500" cy="609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Neuro Exam:</a:t>
            </a:r>
            <a:endParaRPr b="1" dirty="0">
              <a:solidFill>
                <a:srgbClr val="FF0000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</a:t>
            </a:r>
            <a:r>
              <a:rPr lang="en" b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ranial nerves</a:t>
            </a:r>
            <a:endParaRPr b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Mir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quí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ok here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4572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Mire 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t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uz brillante. No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uev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ojos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4572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 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ok at this bright light. Don’t move your eyes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Mire a </a:t>
            </a:r>
            <a:r>
              <a:rPr lang="en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la pared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 err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reloj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ok at </a:t>
            </a:r>
            <a:r>
              <a:rPr lang="en" i="1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the wall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i="1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the clock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Siga mi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ed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No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uev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a cabeza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Follow my finger. Don’t move your head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ierr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ojos. ¿Oy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t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?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lose your eyes. Do you hear this?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Levant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hombr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ift up your shoulders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aqu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a lengua.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ig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“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hhhhh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”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tick out your tongue. Say “</a:t>
            </a:r>
            <a:r>
              <a:rPr lang="en" i="1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hhhhh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”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[Touching temporomandibular joint]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uerd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Bite down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¿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ient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t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? ¿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ient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t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o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ism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n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ambos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ad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?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o you feel this? Do you feel this the same on both sides? 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¡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onrí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!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mile!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ierr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ojos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uy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fuerte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	   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4572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             Close your eyes very tightly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Google Shape;68;p15"/>
          <p:cNvSpPr txBox="1"/>
          <p:nvPr/>
        </p:nvSpPr>
        <p:spPr>
          <a:xfrm>
            <a:off x="287817" y="5813095"/>
            <a:ext cx="3844200" cy="39010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Miscellaneous:</a:t>
            </a:r>
            <a:endParaRPr b="1" dirty="0">
              <a:solidFill>
                <a:srgbClr val="FF0000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Tosa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ough.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Abra la boca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Open your mouth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Haga un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uñ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ake a fist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Suba la manga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ift up your sleeve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óngas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de pie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tand up. </a:t>
            </a: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</a:t>
            </a:r>
            <a:r>
              <a:rPr lang="en-US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– ¡Muy bien!</a:t>
            </a: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Very good!</a:t>
            </a: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</p:txBody>
      </p:sp>
      <p:sp>
        <p:nvSpPr>
          <p:cNvPr id="69" name="Google Shape;69;p15"/>
          <p:cNvSpPr txBox="1"/>
          <p:nvPr/>
        </p:nvSpPr>
        <p:spPr>
          <a:xfrm>
            <a:off x="-217231" y="177736"/>
            <a:ext cx="7938282" cy="56353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4572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Tone &amp; Reflexes</a:t>
            </a:r>
            <a:endParaRPr b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Relaj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_________ (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uñec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braz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iern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rodill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). 	         	   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Relax your (wrist, arm, leg, knee)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Voy a usar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artill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d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reflej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sí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(demonstrate on yourself)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I’m going to use the reflex hammer like this (demonstrate)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</a:t>
            </a:r>
            <a:r>
              <a:rPr lang="en" b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Gait</a:t>
            </a:r>
            <a:endParaRPr b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amin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hasta (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puert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, la pared) y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vuelv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Walk until (the door, the wall) and come back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amin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sí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(demonstrate)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Walk like this (demonstrate)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</a:t>
            </a:r>
            <a:r>
              <a:rPr lang="en" b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Coordination</a:t>
            </a:r>
            <a:endParaRPr b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Toque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u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nariz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Toque mi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ed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…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hor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con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otr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ed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Touch your nose. Touch my finger… Now with the other finger (point to other hand)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Hag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st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con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ed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(demonstrate finger tapping).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hor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con l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otr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mano.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o this with your fingers (demonstrate finger tapping). Now with the other hand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</a:t>
            </a:r>
            <a:r>
              <a:rPr lang="en" b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trength</a:t>
            </a:r>
            <a:endParaRPr b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Manteng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brazo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as </a:t>
            </a:r>
            <a:r>
              <a:rPr lang="en" dirty="0" err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pierna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así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Haga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fuerz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Keep your </a:t>
            </a:r>
            <a:r>
              <a:rPr lang="en" i="1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arms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i="1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egs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like this. Keep them strong. </a:t>
            </a:r>
            <a:endParaRPr i="1"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4572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Doble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braz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a </a:t>
            </a:r>
            <a:r>
              <a:rPr lang="en" dirty="0" err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piern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Enderec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braz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a </a:t>
            </a:r>
            <a:r>
              <a:rPr lang="en" dirty="0" err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piern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4572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	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Bend your </a:t>
            </a:r>
            <a:r>
              <a:rPr lang="en" i="1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arm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i="1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eg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Straighten your </a:t>
            </a:r>
            <a:r>
              <a:rPr lang="en" i="1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arm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i="1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eg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Suba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 pi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a man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Baje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el</a:t>
            </a:r>
            <a:r>
              <a:rPr lang="en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 pi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a mano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Lift up your </a:t>
            </a:r>
            <a:r>
              <a:rPr lang="en" i="1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foot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i="1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hand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Bring down your </a:t>
            </a:r>
            <a:r>
              <a:rPr lang="en" i="1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foot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i="1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hand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/>
          </a:p>
        </p:txBody>
      </p:sp>
      <p:sp>
        <p:nvSpPr>
          <p:cNvPr id="70" name="Google Shape;70;p15"/>
          <p:cNvSpPr txBox="1"/>
          <p:nvPr/>
        </p:nvSpPr>
        <p:spPr>
          <a:xfrm>
            <a:off x="-217231" y="9158146"/>
            <a:ext cx="7453151" cy="6801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</a:t>
            </a:r>
            <a:r>
              <a:rPr lang="en" dirty="0" err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Quítese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calcetine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/ </a:t>
            </a:r>
            <a:r>
              <a:rPr lang="en" dirty="0" err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pantalone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/ </a:t>
            </a:r>
            <a:r>
              <a:rPr lang="en" dirty="0">
                <a:solidFill>
                  <a:srgbClr val="9900FF"/>
                </a:solidFill>
                <a:latin typeface="Oxygen"/>
                <a:ea typeface="Oxygen"/>
                <a:cs typeface="Oxygen"/>
                <a:sym typeface="Oxygen"/>
              </a:rPr>
              <a:t>la camisa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/ </a:t>
            </a:r>
            <a:r>
              <a:rPr lang="en" dirty="0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la </a:t>
            </a:r>
            <a:r>
              <a:rPr lang="en" dirty="0" err="1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camiseta</a:t>
            </a:r>
            <a:r>
              <a:rPr lang="en" dirty="0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>
                <a:solidFill>
                  <a:schemeClr val="tx1"/>
                </a:solidFill>
                <a:latin typeface="Oxygen"/>
                <a:ea typeface="Oxygen"/>
                <a:cs typeface="Oxygen"/>
                <a:sym typeface="Oxygen"/>
              </a:rPr>
              <a:t>/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38761D"/>
                </a:solidFill>
                <a:latin typeface="Oxygen"/>
                <a:ea typeface="Oxygen"/>
                <a:cs typeface="Oxygen"/>
                <a:sym typeface="Oxygen"/>
              </a:rPr>
              <a:t>los</a:t>
            </a:r>
            <a:r>
              <a:rPr lang="en" dirty="0">
                <a:solidFill>
                  <a:srgbClr val="38761D"/>
                </a:solidFill>
                <a:latin typeface="Oxygen"/>
                <a:ea typeface="Oxygen"/>
                <a:cs typeface="Oxygen"/>
                <a:sym typeface="Oxygen"/>
              </a:rPr>
              <a:t> </a:t>
            </a:r>
            <a:r>
              <a:rPr lang="en" dirty="0" err="1">
                <a:solidFill>
                  <a:srgbClr val="38761D"/>
                </a:solidFill>
                <a:latin typeface="Oxygen"/>
                <a:ea typeface="Oxygen"/>
                <a:cs typeface="Oxygen"/>
                <a:sym typeface="Oxygen"/>
              </a:rPr>
              <a:t>lentes</a:t>
            </a: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Take off your </a:t>
            </a:r>
            <a:r>
              <a:rPr lang="en" i="1" dirty="0">
                <a:solidFill>
                  <a:srgbClr val="FF00FF"/>
                </a:solidFill>
                <a:latin typeface="Oxygen"/>
                <a:ea typeface="Oxygen"/>
                <a:cs typeface="Oxygen"/>
                <a:sym typeface="Oxygen"/>
              </a:rPr>
              <a:t>socks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/ </a:t>
            </a:r>
            <a:r>
              <a:rPr lang="en" i="1" dirty="0">
                <a:solidFill>
                  <a:srgbClr val="0000FF"/>
                </a:solidFill>
                <a:latin typeface="Oxygen"/>
                <a:ea typeface="Oxygen"/>
                <a:cs typeface="Oxygen"/>
                <a:sym typeface="Oxygen"/>
              </a:rPr>
              <a:t>pants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/ </a:t>
            </a:r>
            <a:r>
              <a:rPr lang="en" i="1" dirty="0">
                <a:solidFill>
                  <a:srgbClr val="9900FF"/>
                </a:solidFill>
                <a:latin typeface="Oxygen"/>
                <a:ea typeface="Oxygen"/>
                <a:cs typeface="Oxygen"/>
                <a:sym typeface="Oxygen"/>
              </a:rPr>
              <a:t>shirt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/ </a:t>
            </a:r>
            <a:r>
              <a:rPr lang="en" i="1" dirty="0">
                <a:solidFill>
                  <a:srgbClr val="FF0000"/>
                </a:solidFill>
                <a:latin typeface="Oxygen"/>
                <a:ea typeface="Oxygen"/>
                <a:cs typeface="Oxygen"/>
                <a:sym typeface="Oxygen"/>
              </a:rPr>
              <a:t>t-shirt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 /  </a:t>
            </a:r>
            <a:r>
              <a:rPr lang="en" i="1" dirty="0">
                <a:solidFill>
                  <a:srgbClr val="38761D"/>
                </a:solidFill>
                <a:latin typeface="Oxygen"/>
                <a:ea typeface="Oxygen"/>
                <a:cs typeface="Oxygen"/>
                <a:sym typeface="Oxygen"/>
              </a:rPr>
              <a:t>glasses</a:t>
            </a:r>
            <a:r>
              <a:rPr lang="en" i="1" dirty="0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. </a:t>
            </a:r>
            <a:endParaRPr dirty="0"/>
          </a:p>
        </p:txBody>
      </p:sp>
      <p:sp>
        <p:nvSpPr>
          <p:cNvPr id="71" name="Google Shape;71;p15"/>
          <p:cNvSpPr txBox="1"/>
          <p:nvPr/>
        </p:nvSpPr>
        <p:spPr>
          <a:xfrm>
            <a:off x="3305050" y="6270325"/>
            <a:ext cx="3853050" cy="26493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Boca arriba. Boca abajo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Face up. Face down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¿Le duele cuando hago esto?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Does it hurt when I do this?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Trague saliva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wallow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Apriete mis dedos. 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Squeeze my fingers. </a:t>
            </a:r>
            <a:endParaRPr i="1"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– Tóquese los dedos de los pies.</a:t>
            </a:r>
            <a:endParaRPr>
              <a:solidFill>
                <a:schemeClr val="dk1"/>
              </a:solidFill>
              <a:latin typeface="Oxygen"/>
              <a:ea typeface="Oxygen"/>
              <a:cs typeface="Oxygen"/>
              <a:sym typeface="Oxygen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	   </a:t>
            </a:r>
            <a:r>
              <a:rPr lang="en" i="1">
                <a:solidFill>
                  <a:schemeClr val="dk1"/>
                </a:solidFill>
                <a:latin typeface="Oxygen"/>
                <a:ea typeface="Oxygen"/>
                <a:cs typeface="Oxygen"/>
                <a:sym typeface="Oxygen"/>
              </a:rPr>
              <a:t>Touch your toes. </a:t>
            </a:r>
            <a:endParaRPr/>
          </a:p>
        </p:txBody>
      </p:sp>
      <p:cxnSp>
        <p:nvCxnSpPr>
          <p:cNvPr id="72" name="Google Shape;72;p15"/>
          <p:cNvCxnSpPr>
            <a:cxnSpLocks/>
          </p:cNvCxnSpPr>
          <p:nvPr/>
        </p:nvCxnSpPr>
        <p:spPr>
          <a:xfrm>
            <a:off x="3796900" y="6269922"/>
            <a:ext cx="0" cy="2764055"/>
          </a:xfrm>
          <a:prstGeom prst="straightConnector1">
            <a:avLst/>
          </a:prstGeom>
          <a:noFill/>
          <a:ln w="28575" cap="flat" cmpd="sng">
            <a:solidFill>
              <a:schemeClr val="dk2"/>
            </a:solidFill>
            <a:prstDash val="solid"/>
            <a:round/>
            <a:headEnd type="none" w="med" len="med"/>
            <a:tailEnd type="none" w="med" len="med"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8</TotalTime>
  <Words>1110</Words>
  <Application>Microsoft Macintosh PowerPoint</Application>
  <PresentationFormat>Custom</PresentationFormat>
  <Paragraphs>1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Oxygen</vt:lpstr>
      <vt:lpstr>Simple Light</vt:lpstr>
      <vt:lpstr>Using Spanish During a Physical Exam Developed by Andrew Bueno &amp; Helen Woolcock ‘MS4 with help from Dr. Ana Esteba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sing Spanish During a Physical Exam Developed by Andrew Bueno &amp; Helen Woolcock ‘MS4 with help from Dr. Ana Esteban</dc:title>
  <cp:lastModifiedBy>Bueno, Andrew N.</cp:lastModifiedBy>
  <cp:revision>7</cp:revision>
  <dcterms:modified xsi:type="dcterms:W3CDTF">2025-01-21T03:04:14Z</dcterms:modified>
</cp:coreProperties>
</file>